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tif" ContentType="image/tiff"/>
  <Default Extension="tiff" ContentType="image/tiff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1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oris Roth" initials="DR" lastIdx="1" clrIdx="0">
    <p:extLst>
      <p:ext uri="{19B8F6BF-5375-455C-9EA6-DF929625EA0E}">
        <p15:presenceInfo xmlns:p15="http://schemas.microsoft.com/office/powerpoint/2012/main" userId="9157e905874b8795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00000"/>
    <a:srgbClr val="002AFF"/>
    <a:srgbClr val="FF2500"/>
    <a:srgbClr val="FFFF00"/>
    <a:srgbClr val="8FFF70"/>
    <a:srgbClr val="00FFFF"/>
    <a:srgbClr val="850000"/>
    <a:srgbClr val="00008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90" y="96"/>
      </p:cViewPr>
      <p:guideLst>
        <p:guide orient="horz" pos="201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62DF3-AE42-4345-966C-11C7ED37E2E9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97E2EB-91EE-45F6-954F-3B01ADE326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710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AC4BF-8A59-782B-3881-1C24A15225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E894C1-841E-E969-C194-4398FD50EA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B1516D-11F1-34F8-9E51-13E3E390E8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530BC-D4E4-B969-06DD-1C5CC5CB5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AE5072-4FF7-510E-05DE-FFDD178B0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9032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BC3B8E-23ED-D357-0DD2-1495320DE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16053DC-807D-FD06-34CF-5D306FE3EF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632A85-4ED8-4D83-F28B-A97D07FB7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5760A4-A0AA-0977-2E56-E4EAC7A3F5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EDD529-9930-DB85-8CD3-66DA71D0D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082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FBD82C-F5E9-7ABB-17F1-7A371D67FC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CFEB42-DA43-2F2B-C3BC-5C2BED05F0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7E0B77-BC7F-A9AD-FFF9-419530352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3B6B29-13B6-FDE9-E4AB-5972A6CCB3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554D3-E1CC-45AB-9FEE-4922300B8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5062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6C5445-A6D3-55C7-AD5C-47DBF6AB78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EB56E0-44B4-1E22-C868-F7A36969E0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86B33D-8D36-85A0-8FFB-3A01C7FC6C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9E2A94-4792-59BA-C827-DFAF844747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A950F8-AB75-227D-5044-1FE611A68A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2703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543A66-93D4-25D4-3791-9484C5EF59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624B63-D6FE-85CE-697A-6A36542072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C7EA77-0903-CB33-17EC-1B0A96720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C02554-D27D-9F9F-B5E3-3255AA1A16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E5B164-D53E-0F9A-0BC1-F4389938D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346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56BD7-8BBD-25FC-E958-490BE3B78F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E69DB4-0017-87F8-9CC3-4F6ED148A2A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804A44-72A8-B12C-0BAA-6C21466978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BA40C0-D608-37C6-D290-58D79EF37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36FD2C-9A35-85DD-F126-582D1D8328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F2EEA3-3557-CE99-D36D-C8646E607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873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264B1-F283-FC05-4B1E-B5EE4F522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B5302C-42D9-602F-FF55-BA0D1E8A65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97E8CBB-0553-852C-8DD3-ACA51DF26C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E63BB5C-CBB9-ED95-1C4D-69867CC7C4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029ACB-4CC6-DCAC-2755-B976197C3F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F54A990-4FDA-074D-7C43-C791AED17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5327A54-80E2-28EA-F037-5AAFD1E4F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D0A6BE-8AF3-CCBF-75DB-51AAD1C9D5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5594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12574-BC98-4C23-AF18-CD0DAC10C9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FAF27D3-013D-1CC0-D71D-22DD179893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97552F-8094-A356-3EBA-E1B28A21C3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BD4260-E158-9820-F389-D74DCA3C8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649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D8E1E4F-B7CF-E405-F2F5-6086D33371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651EFCD-F342-2956-3311-75AC53E4F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6BCB21-E887-5589-12FC-95754D4D4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410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87CC96-B7B6-0FC8-97CE-9C8017BA94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B8F2E9-6F53-CFC9-6998-74CC6B1EFC5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1AE2A5-75FC-3AB8-FEB8-2CB6D0548E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665E85-9203-766F-FE8D-DF5485616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94B2B8-A50D-EA48-92C1-474F592C1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FB4395-F802-61BA-5D6C-80E4BB4049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258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DB3C3C-C714-3671-2C60-F0B6F008EC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D0B680-5247-093E-9468-5DA7E8BDDC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21295-856B-DC64-0C5E-DFA04EFAD2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2492A5-1498-CC30-6D6D-51CC52516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6B4DAF-A56A-3E22-D86B-24E17CC4A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A53D72-2488-47F2-9AF9-47F4ECEEA7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1685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61D47A7-8945-F645-CF32-ED7E3E3453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C13D38-EB84-9D3A-ABAC-ECA36EC22B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6D5AAA-8327-B071-9E47-5D1EAC473D7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4E3BC-E6F1-486A-A42A-6077853E9704}" type="datetimeFigureOut">
              <a:rPr lang="en-US" smtClean="0"/>
              <a:t>5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ED24E0-55CA-A341-D265-43A3EC3AE7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AF035-C1FE-4B53-C26B-0F49FF5AB6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B2323-3DE0-4F37-84DE-40C0AB639C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4724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4.png"/><Relationship Id="rId3" Type="http://schemas.microsoft.com/office/2007/relationships/media" Target="../media/media2.avi"/><Relationship Id="rId7" Type="http://schemas.microsoft.com/office/2007/relationships/media" Target="../media/media4.mp4"/><Relationship Id="rId12" Type="http://schemas.openxmlformats.org/officeDocument/2006/relationships/image" Target="../media/image3.tif"/><Relationship Id="rId17" Type="http://schemas.openxmlformats.org/officeDocument/2006/relationships/image" Target="../media/image8.png"/><Relationship Id="rId2" Type="http://schemas.openxmlformats.org/officeDocument/2006/relationships/video" Target="../media/media1.avi"/><Relationship Id="rId16" Type="http://schemas.openxmlformats.org/officeDocument/2006/relationships/image" Target="../media/image7.tiff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11" Type="http://schemas.openxmlformats.org/officeDocument/2006/relationships/image" Target="../media/image2.tif"/><Relationship Id="rId5" Type="http://schemas.microsoft.com/office/2007/relationships/media" Target="../media/media3.avi"/><Relationship Id="rId15" Type="http://schemas.openxmlformats.org/officeDocument/2006/relationships/image" Target="../media/image6.png"/><Relationship Id="rId10" Type="http://schemas.openxmlformats.org/officeDocument/2006/relationships/image" Target="../media/image1.tif"/><Relationship Id="rId4" Type="http://schemas.openxmlformats.org/officeDocument/2006/relationships/video" Target="../media/media2.avi"/><Relationship Id="rId9" Type="http://schemas.openxmlformats.org/officeDocument/2006/relationships/slideLayout" Target="../slideLayouts/slideLayout7.xml"/><Relationship Id="rId1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green, invertebrate, worm&#10;&#10;Description automatically generated">
            <a:extLst>
              <a:ext uri="{FF2B5EF4-FFF2-40B4-BE49-F238E27FC236}">
                <a16:creationId xmlns:a16="http://schemas.microsoft.com/office/drawing/2014/main" id="{4917A7AB-1CCD-9AFC-8A15-2E691CE396F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4659" y="3761241"/>
            <a:ext cx="1628398" cy="162839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7EFB050-DA7C-2D12-F811-99E75EA59D15}"/>
              </a:ext>
            </a:extLst>
          </p:cNvPr>
          <p:cNvSpPr txBox="1"/>
          <p:nvPr/>
        </p:nvSpPr>
        <p:spPr>
          <a:xfrm>
            <a:off x="1667632" y="5487387"/>
            <a:ext cx="3412369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Video S3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ft: Example of ciliary beat of IPSC-derived DNAH5-mutant airway epithelial cells in suspension. Movie recorded at 20 fps and played back at 100 fps. Right: Live-dead stain of same field of view showing that recorded cells were alive (green signal) and not dead or dying (red signal). 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 descr="A close up of a person's eye&#10;&#10;Description automatically generated with low confidence">
            <a:extLst>
              <a:ext uri="{FF2B5EF4-FFF2-40B4-BE49-F238E27FC236}">
                <a16:creationId xmlns:a16="http://schemas.microsoft.com/office/drawing/2014/main" id="{EF6EE2FC-11AC-9BE7-5CF8-BAB0B7B46A7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9310" y="3761242"/>
            <a:ext cx="1628398" cy="1628398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6F0C442B-F4A2-063F-EF39-EC104329F7BF}"/>
              </a:ext>
            </a:extLst>
          </p:cNvPr>
          <p:cNvSpPr txBox="1"/>
          <p:nvPr/>
        </p:nvSpPr>
        <p:spPr>
          <a:xfrm>
            <a:off x="5174496" y="5456925"/>
            <a:ext cx="3412369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Video S4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ft: Example of ciliary beat of IPSC-derived NME5-mutant airway epithelial cells in suspension. Movie recorded at 800 fps and played back at 20 fps. Right: Live-dead stain of same field of view showing that recorded cells were alive (green signal) and not dead or dying (red signal). 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 descr="A close up of a person's face&#10;&#10;Description automatically generated with low confidence">
            <a:extLst>
              <a:ext uri="{FF2B5EF4-FFF2-40B4-BE49-F238E27FC236}">
                <a16:creationId xmlns:a16="http://schemas.microsoft.com/office/drawing/2014/main" id="{4FB495EA-C54C-D3DA-84B6-800812EDB157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8579" y="358850"/>
            <a:ext cx="1628398" cy="1628398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D7713C23-214C-D9C9-AEDC-C3A25A3246A0}"/>
              </a:ext>
            </a:extLst>
          </p:cNvPr>
          <p:cNvSpPr txBox="1"/>
          <p:nvPr/>
        </p:nvSpPr>
        <p:spPr>
          <a:xfrm>
            <a:off x="1606248" y="2054533"/>
            <a:ext cx="3517673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Video S1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ft: Example of ciliary beat of primary airway epithelial cells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pAL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in suspension. Movie recorded at 800 fps and played back at 20 fps. Right: Live-dead stain of same field of view showing that recorded cells were alive (green signal) and not dead or dying (red signal). 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5C09BD-E9E3-FFD1-DE84-535FD24AE112}"/>
              </a:ext>
            </a:extLst>
          </p:cNvPr>
          <p:cNvSpPr txBox="1"/>
          <p:nvPr/>
        </p:nvSpPr>
        <p:spPr>
          <a:xfrm>
            <a:off x="5174496" y="1979920"/>
            <a:ext cx="3517673" cy="11079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. Video S2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eft: Example of ciliary beat of primary airway epithelial cells (non PC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ALI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in suspension. Movie recorded at 800 fps and played back at 20 fps. Right: Live-dead stain of same field of view showing that recorded cells were alive (green signal) and not dead or dying (red signal). </a:t>
            </a:r>
            <a:endParaRPr lang="en-US" sz="11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ALI_iso24_01-17_800fps_playback20fps-1">
            <a:hlinkClick r:id="" action="ppaction://media"/>
            <a:extLst>
              <a:ext uri="{FF2B5EF4-FFF2-40B4-BE49-F238E27FC236}">
                <a16:creationId xmlns:a16="http://schemas.microsoft.com/office/drawing/2014/main" id="{6B808BA1-16C2-A0FB-EEE2-2F8D3648E67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13"/>
          <a:stretch>
            <a:fillRect/>
          </a:stretch>
        </p:blipFill>
        <p:spPr>
          <a:xfrm>
            <a:off x="1649491" y="358850"/>
            <a:ext cx="1628398" cy="1628398"/>
          </a:xfrm>
          <a:prstGeom prst="rect">
            <a:avLst/>
          </a:prstGeom>
        </p:spPr>
      </p:pic>
      <p:pic>
        <p:nvPicPr>
          <p:cNvPr id="23" name="NME5_Cl23_diff41_800fps_02-08_20fpsplayback">
            <a:hlinkClick r:id="" action="ppaction://media"/>
            <a:extLst>
              <a:ext uri="{FF2B5EF4-FFF2-40B4-BE49-F238E27FC236}">
                <a16:creationId xmlns:a16="http://schemas.microsoft.com/office/drawing/2014/main" id="{031629BB-29AA-4A43-1C76-B66E7A7756EF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4"/>
          <a:stretch>
            <a:fillRect/>
          </a:stretch>
        </p:blipFill>
        <p:spPr>
          <a:xfrm>
            <a:off x="5234595" y="3761241"/>
            <a:ext cx="1628398" cy="1628398"/>
          </a:xfrm>
          <a:prstGeom prst="rect">
            <a:avLst/>
          </a:prstGeom>
        </p:spPr>
      </p:pic>
      <p:pic>
        <p:nvPicPr>
          <p:cNvPr id="25" name="DNAH5_Cl22_diff3d_800fps_01-20_Playback20fps-1">
            <a:hlinkClick r:id="" action="ppaction://media"/>
            <a:extLst>
              <a:ext uri="{FF2B5EF4-FFF2-40B4-BE49-F238E27FC236}">
                <a16:creationId xmlns:a16="http://schemas.microsoft.com/office/drawing/2014/main" id="{C18480EC-21CE-64A1-702B-DF51A0787FBF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5"/>
          <a:stretch>
            <a:fillRect/>
          </a:stretch>
        </p:blipFill>
        <p:spPr>
          <a:xfrm>
            <a:off x="1667632" y="3761241"/>
            <a:ext cx="1628398" cy="1628398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49874" y="376343"/>
            <a:ext cx="1532648" cy="1621070"/>
          </a:xfrm>
          <a:prstGeom prst="rect">
            <a:avLst/>
          </a:prstGeom>
        </p:spPr>
      </p:pic>
      <p:pic>
        <p:nvPicPr>
          <p:cNvPr id="3" name="Phoenix_diff2d_CBF_TW_01-21">
            <a:hlinkClick r:id="" action="ppaction://media"/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>
          <a:blip r:embed="rId17"/>
          <a:stretch>
            <a:fillRect/>
          </a:stretch>
        </p:blipFill>
        <p:spPr>
          <a:xfrm>
            <a:off x="5120786" y="358850"/>
            <a:ext cx="1601658" cy="16385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228141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000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20000" fill="hold"/>
                                        <p:tgtEl>
                                          <p:spTgt spid="2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20050" fill="hold"/>
                                        <p:tgtEl>
                                          <p:spTgt spid="2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22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2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2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2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23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2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2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3"/>
                  </p:tgtEl>
                </p:cond>
              </p:nextCondLst>
            </p:seq>
            <p:video>
              <p:cMediaNode vol="80000">
                <p:cTn id="27" fill="hold" display="0">
                  <p:stCondLst>
                    <p:cond delay="indefinite"/>
                  </p:stCondLst>
                </p:cTn>
                <p:tgtEl>
                  <p:spTgt spid="25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2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2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5"/>
                  </p:tgtEl>
                </p:cond>
              </p:nextCondLst>
            </p:seq>
            <p:seq concurrent="1" nextAc="seek">
              <p:cTn id="33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4" fill="hold">
                      <p:stCondLst>
                        <p:cond delay="0"/>
                      </p:stCondLst>
                      <p:childTnLst>
                        <p:par>
                          <p:cTn id="35" fill="hold">
                            <p:stCondLst>
                              <p:cond delay="0"/>
                            </p:stCondLst>
                            <p:childTnLst>
                              <p:par>
                                <p:cTn id="36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7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38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46</Words>
  <Application>Microsoft Office PowerPoint</Application>
  <PresentationFormat>Widescreen</PresentationFormat>
  <Paragraphs>4</Paragraphs>
  <Slides>1</Slides>
  <Notes>0</Notes>
  <HiddenSlides>0</HiddenSlides>
  <MMClips>4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na Nawroth</dc:creator>
  <cp:lastModifiedBy>MDPI</cp:lastModifiedBy>
  <cp:revision>42</cp:revision>
  <dcterms:created xsi:type="dcterms:W3CDTF">2023-02-04T08:59:10Z</dcterms:created>
  <dcterms:modified xsi:type="dcterms:W3CDTF">2023-05-24T08:56:24Z</dcterms:modified>
</cp:coreProperties>
</file>